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27" autoAdjust="0"/>
    <p:restoredTop sz="87803" autoAdjust="0"/>
  </p:normalViewPr>
  <p:slideViewPr>
    <p:cSldViewPr snapToGrid="0">
      <p:cViewPr varScale="1">
        <p:scale>
          <a:sx n="74" d="100"/>
          <a:sy n="74" d="100"/>
        </p:scale>
        <p:origin x="105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EED499-3E26-4DCC-96DE-FB36FA0A45B6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0ECE59-F2B3-4465-BD19-6D633C072C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8705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C818DE-4477-573E-938F-7AAF85368E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D358262-B2FD-9549-A2EC-8CCED497BA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8D6F60-9D8B-B762-69D3-5CDD5FEE2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02F378-A087-D3CD-5E67-203A5C596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D2691F-36C5-CDD9-DBE5-FC9E0F711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4486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446912-FDBB-2DAF-ADCC-8542C5C259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79D6E8-232F-382C-7682-7BDBF95293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C78DA20-A60C-970A-8C70-CB7E17040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A58634-8C7F-C79D-42FC-6004CE84E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ACC996-BEDC-0CB8-C1E0-3E420A339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2316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73D9D1F-2E15-EC7C-2E0C-B8F68A3380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F8BF680-8A85-C8B7-8309-464D394217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5A7418-46E7-E804-3D57-1FD500711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FB3D53-FF88-83FA-FA28-0A72CA0B1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5448B1-94B5-9FF0-B065-16CB05272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3534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B50CBC-0D81-4C0E-0269-D6DA28C892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ACFB184-53AF-3081-35B4-0B9D822EDC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5CA23F-B8FC-BDBB-5808-B4BE695DB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5395F7-4A77-1C5A-4EA4-65EC7922C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DABC20-1A64-BEFE-9986-E161163B4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8243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7F05AB-EA59-85C7-5192-965F8CB711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0EABDA-7F51-DC86-4A57-D3E2E22654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2A81B7-74BF-921B-324E-74AFE3657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A622CB-A7F5-3FB1-9BEA-666572944A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C22CCD-BC52-134B-53BD-01883B699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3408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C2C329-2330-4AD9-C31E-839954A83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C520EA4-20D0-06AB-E5E5-CB090EEFE2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6ED763-3ADC-09C1-E5B6-CF464A3802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449045-BDF8-03B3-620B-8B2C5DF46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1EC0BBD-A86D-10B7-5B74-C058331EE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189269-68B7-483C-89F9-3CF0BDD76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970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ACEB99-BBE8-98C9-869A-D973BEB5E4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3CB9D31-361D-E977-E067-20C5D9E332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E24978-917A-96A2-6BE9-F6177E4C8D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7A99F8A-F5E0-3423-474A-130A8FA7CB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17B1F1A-96DC-9090-50B8-E5FA59E1C6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9E09AA6-7316-1638-34B0-1754A8689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8B40C36-759F-E911-7070-D26001A52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129F229-AAF3-7507-3106-5346AF927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3630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1A36E2-37CB-2AD0-6097-CB16D72B76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088C339-4E46-5F8D-CF0B-C5B54D615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46CB88C-97F0-855E-446A-E1B3F6344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F95324A-659A-177A-9D02-C6F2E8789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451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34763E4-9D45-CAA8-6B1B-112686E01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2D49E85-B6D5-D8C0-B0A2-CDC75A5E6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FB0977F-C724-813E-6F29-007D252A5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5243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AAF932-BD10-F65A-588C-83C7FC744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7846A75-74A5-19DE-1628-FD8C5A40FA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C4665F-3EA4-1C42-0726-5E68AACD45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C866D56-FB43-A58B-5842-257F3BB22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EE804CD-6985-6534-805B-61B816114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4C2EC4-3A82-93E2-8CD0-9EA2F3036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0409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A372CD-AB4C-B531-BCE9-1CD0FD6E2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4C46CEA-4F4F-357F-C141-763D7C8432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A70075-FADC-EF37-01E5-C661A120F9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A1307F-3E53-D706-3DE1-81D3114F7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95AB0D-C570-492D-5BE8-1D6BDB77D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CDA309-5D46-69D2-B872-332C1594E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876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D21CF78-D865-D2CA-EE01-A550A64235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FE11C2-700A-4B52-D7F3-3DDD025750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BDF5CF-9DB8-834B-DD73-5C0A92958C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AC611-2D4F-4449-9A4A-2B899C08E424}" type="datetimeFigureOut">
              <a:rPr lang="zh-CN" altLang="en-US" smtClean="0"/>
              <a:t>2025/12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6F8B56-D359-21D4-D58F-DC2CB2164C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1465D6-161C-1D0C-DE6F-43A6827248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14CAC-702D-4E30-B6B0-AD302A3C45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5757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0568CCE-B424-33DD-8F59-CD51576D1F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3898" y="322813"/>
            <a:ext cx="5665943" cy="566594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055210C-8238-D2ED-7032-9F3CE7C7C1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314" y="322813"/>
            <a:ext cx="3167233" cy="278988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5D3410B-4E53-39D8-D269-42970FA7925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315" y="3205055"/>
            <a:ext cx="3167233" cy="278370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0314E80-D075-E074-5D68-E7F9DF335BA6}"/>
              </a:ext>
            </a:extLst>
          </p:cNvPr>
          <p:cNvSpPr txBox="1"/>
          <p:nvPr/>
        </p:nvSpPr>
        <p:spPr>
          <a:xfrm>
            <a:off x="25757" y="6257133"/>
            <a:ext cx="121404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</a:rPr>
              <a:t>PET/CT demonstrated increased FDG uptake (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e arrow</a:t>
            </a:r>
            <a:r>
              <a:rPr lang="en-US" altLang="zh-CN" dirty="0">
                <a:latin typeface="Times New Roman" panose="02020603050405020304" pitchFamily="18" charset="0"/>
              </a:rPr>
              <a:t>) in the left supraclavicular lymph node (A) and T10 vertebra (B</a:t>
            </a:r>
            <a:r>
              <a:rPr lang="zh-CN" altLang="en-US" dirty="0">
                <a:latin typeface="Times New Roman" panose="02020603050405020304" pitchFamily="18" charset="0"/>
              </a:rPr>
              <a:t>、</a:t>
            </a:r>
            <a:r>
              <a:rPr lang="en-US" altLang="zh-CN" dirty="0">
                <a:latin typeface="Times New Roman" panose="02020603050405020304" pitchFamily="18" charset="0"/>
              </a:rPr>
              <a:t>C).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AF79B46-70E4-A2D1-2253-6EACD033DCD6}"/>
              </a:ext>
            </a:extLst>
          </p:cNvPr>
          <p:cNvSpPr txBox="1"/>
          <p:nvPr/>
        </p:nvSpPr>
        <p:spPr>
          <a:xfrm>
            <a:off x="4381608" y="416201"/>
            <a:ext cx="351378" cy="369332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8C8B953-C1D1-9536-9402-D139EE75539C}"/>
              </a:ext>
            </a:extLst>
          </p:cNvPr>
          <p:cNvSpPr txBox="1"/>
          <p:nvPr/>
        </p:nvSpPr>
        <p:spPr>
          <a:xfrm>
            <a:off x="7292613" y="387203"/>
            <a:ext cx="351378" cy="369332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C6A033D-3868-90CB-DB80-5820086E89A6}"/>
              </a:ext>
            </a:extLst>
          </p:cNvPr>
          <p:cNvSpPr txBox="1"/>
          <p:nvPr/>
        </p:nvSpPr>
        <p:spPr>
          <a:xfrm>
            <a:off x="4368730" y="3297467"/>
            <a:ext cx="351378" cy="369332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5873C027-E60C-0DEC-BC0A-372042915C07}"/>
              </a:ext>
            </a:extLst>
          </p:cNvPr>
          <p:cNvCxnSpPr>
            <a:cxnSpLocks/>
          </p:cNvCxnSpPr>
          <p:nvPr/>
        </p:nvCxnSpPr>
        <p:spPr>
          <a:xfrm flipH="1" flipV="1">
            <a:off x="3432173" y="1397806"/>
            <a:ext cx="138739" cy="187115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A5ADE3E7-63AE-9DFB-277F-A2DEB313F498}"/>
              </a:ext>
            </a:extLst>
          </p:cNvPr>
          <p:cNvCxnSpPr>
            <a:cxnSpLocks/>
          </p:cNvCxnSpPr>
          <p:nvPr/>
        </p:nvCxnSpPr>
        <p:spPr>
          <a:xfrm flipH="1" flipV="1">
            <a:off x="3243283" y="4822770"/>
            <a:ext cx="138739" cy="187115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56EAF7AD-B117-F3EB-F08F-3A81B94529A5}"/>
              </a:ext>
            </a:extLst>
          </p:cNvPr>
          <p:cNvCxnSpPr>
            <a:cxnSpLocks/>
          </p:cNvCxnSpPr>
          <p:nvPr/>
        </p:nvCxnSpPr>
        <p:spPr>
          <a:xfrm flipH="1" flipV="1">
            <a:off x="6280551" y="5419491"/>
            <a:ext cx="138739" cy="187115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484196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87</TotalTime>
  <Words>32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MING JIN</dc:creator>
  <cp:lastModifiedBy>金英明</cp:lastModifiedBy>
  <cp:revision>31</cp:revision>
  <dcterms:created xsi:type="dcterms:W3CDTF">2025-06-15T15:59:50Z</dcterms:created>
  <dcterms:modified xsi:type="dcterms:W3CDTF">2025-12-31T02:40:06Z</dcterms:modified>
</cp:coreProperties>
</file>